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9" r:id="rId3"/>
    <p:sldId id="257" r:id="rId4"/>
    <p:sldId id="258"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690BDD1-8C68-EF46-A401-245660F0AAA3}" v="14" dt="2022-09-02T06:57:51.07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992" autoAdjust="0"/>
    <p:restoredTop sz="88328" autoAdjust="0"/>
  </p:normalViewPr>
  <p:slideViewPr>
    <p:cSldViewPr snapToGrid="0">
      <p:cViewPr varScale="1">
        <p:scale>
          <a:sx n="96" d="100"/>
          <a:sy n="96" d="100"/>
        </p:scale>
        <p:origin x="1024"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u, Jin" userId="d0df0faf-f7e8-46e3-af8b-ed9c0c8d920b" providerId="ADAL" clId="{1690BDD1-8C68-EF46-A401-245660F0AAA3}"/>
    <pc:docChg chg="custSel addSld modSld">
      <pc:chgData name="Xu, Jin" userId="d0df0faf-f7e8-46e3-af8b-ed9c0c8d920b" providerId="ADAL" clId="{1690BDD1-8C68-EF46-A401-245660F0AAA3}" dt="2022-09-02T06:58:12.364" v="149" actId="1076"/>
      <pc:docMkLst>
        <pc:docMk/>
      </pc:docMkLst>
      <pc:sldChg chg="addSp delSp modSp mod">
        <pc:chgData name="Xu, Jin" userId="d0df0faf-f7e8-46e3-af8b-ed9c0c8d920b" providerId="ADAL" clId="{1690BDD1-8C68-EF46-A401-245660F0AAA3}" dt="2022-09-02T06:51:47.641" v="55" actId="14100"/>
        <pc:sldMkLst>
          <pc:docMk/>
          <pc:sldMk cId="3959288222" sldId="256"/>
        </pc:sldMkLst>
        <pc:spChg chg="mod">
          <ac:chgData name="Xu, Jin" userId="d0df0faf-f7e8-46e3-af8b-ed9c0c8d920b" providerId="ADAL" clId="{1690BDD1-8C68-EF46-A401-245660F0AAA3}" dt="2022-09-02T06:51:47.641" v="55" actId="14100"/>
          <ac:spMkLst>
            <pc:docMk/>
            <pc:sldMk cId="3959288222" sldId="256"/>
            <ac:spMk id="5" creationId="{9C3FBBB3-35B4-414F-8BEA-E77B2E1F8A75}"/>
          </ac:spMkLst>
        </pc:spChg>
        <pc:spChg chg="add mod">
          <ac:chgData name="Xu, Jin" userId="d0df0faf-f7e8-46e3-af8b-ed9c0c8d920b" providerId="ADAL" clId="{1690BDD1-8C68-EF46-A401-245660F0AAA3}" dt="2022-09-02T06:51:07.276" v="46" actId="20577"/>
          <ac:spMkLst>
            <pc:docMk/>
            <pc:sldMk cId="3959288222" sldId="256"/>
            <ac:spMk id="8" creationId="{5B64F5DD-FBA7-9403-0BDB-E05105542B05}"/>
          </ac:spMkLst>
        </pc:spChg>
        <pc:spChg chg="add mod">
          <ac:chgData name="Xu, Jin" userId="d0df0faf-f7e8-46e3-af8b-ed9c0c8d920b" providerId="ADAL" clId="{1690BDD1-8C68-EF46-A401-245660F0AAA3}" dt="2022-09-02T06:51:22.507" v="52" actId="20577"/>
          <ac:spMkLst>
            <pc:docMk/>
            <pc:sldMk cId="3959288222" sldId="256"/>
            <ac:spMk id="9" creationId="{37A78822-335E-3D9C-DBD6-5C3CC159DE88}"/>
          </ac:spMkLst>
        </pc:spChg>
        <pc:grpChg chg="add">
          <ac:chgData name="Xu, Jin" userId="d0df0faf-f7e8-46e3-af8b-ed9c0c8d920b" providerId="ADAL" clId="{1690BDD1-8C68-EF46-A401-245660F0AAA3}" dt="2022-09-02T06:51:38.612" v="53" actId="164"/>
          <ac:grpSpMkLst>
            <pc:docMk/>
            <pc:sldMk cId="3959288222" sldId="256"/>
            <ac:grpSpMk id="10" creationId="{C1D72D68-34A3-4F79-3D54-D24EC943C4A2}"/>
          </ac:grpSpMkLst>
        </pc:grpChg>
        <pc:picChg chg="add mod">
          <ac:chgData name="Xu, Jin" userId="d0df0faf-f7e8-46e3-af8b-ed9c0c8d920b" providerId="ADAL" clId="{1690BDD1-8C68-EF46-A401-245660F0AAA3}" dt="2022-09-02T06:50:07.413" v="14" actId="1076"/>
          <ac:picMkLst>
            <pc:docMk/>
            <pc:sldMk cId="3959288222" sldId="256"/>
            <ac:picMk id="3" creationId="{67C1DF23-B332-F557-C99E-C7059AEABB6D}"/>
          </ac:picMkLst>
        </pc:picChg>
        <pc:picChg chg="del">
          <ac:chgData name="Xu, Jin" userId="d0df0faf-f7e8-46e3-af8b-ed9c0c8d920b" providerId="ADAL" clId="{1690BDD1-8C68-EF46-A401-245660F0AAA3}" dt="2022-09-02T06:47:37.714" v="4" actId="478"/>
          <ac:picMkLst>
            <pc:docMk/>
            <pc:sldMk cId="3959288222" sldId="256"/>
            <ac:picMk id="4" creationId="{14639323-865B-4B71-9248-1C1A3246C550}"/>
          </ac:picMkLst>
        </pc:picChg>
        <pc:picChg chg="add mod">
          <ac:chgData name="Xu, Jin" userId="d0df0faf-f7e8-46e3-af8b-ed9c0c8d920b" providerId="ADAL" clId="{1690BDD1-8C68-EF46-A401-245660F0AAA3}" dt="2022-09-02T06:50:23.725" v="29" actId="1038"/>
          <ac:picMkLst>
            <pc:docMk/>
            <pc:sldMk cId="3959288222" sldId="256"/>
            <ac:picMk id="7" creationId="{CCB5E968-09EB-74D0-3817-1B8B8CA45C35}"/>
          </ac:picMkLst>
        </pc:picChg>
      </pc:sldChg>
      <pc:sldChg chg="addSp delSp modSp mod">
        <pc:chgData name="Xu, Jin" userId="d0df0faf-f7e8-46e3-af8b-ed9c0c8d920b" providerId="ADAL" clId="{1690BDD1-8C68-EF46-A401-245660F0AAA3}" dt="2022-09-02T06:56:51.497" v="128" actId="164"/>
        <pc:sldMkLst>
          <pc:docMk/>
          <pc:sldMk cId="331892010" sldId="257"/>
        </pc:sldMkLst>
        <pc:spChg chg="mod">
          <ac:chgData name="Xu, Jin" userId="d0df0faf-f7e8-46e3-af8b-ed9c0c8d920b" providerId="ADAL" clId="{1690BDD1-8C68-EF46-A401-245660F0AAA3}" dt="2022-09-02T06:55:26.747" v="109" actId="20577"/>
          <ac:spMkLst>
            <pc:docMk/>
            <pc:sldMk cId="331892010" sldId="257"/>
            <ac:spMk id="3" creationId="{D64A9041-ECAD-4673-8026-FAABEEFB697D}"/>
          </ac:spMkLst>
        </pc:spChg>
        <pc:spChg chg="add mod">
          <ac:chgData name="Xu, Jin" userId="d0df0faf-f7e8-46e3-af8b-ed9c0c8d920b" providerId="ADAL" clId="{1690BDD1-8C68-EF46-A401-245660F0AAA3}" dt="2022-09-02T06:56:31.437" v="123"/>
          <ac:spMkLst>
            <pc:docMk/>
            <pc:sldMk cId="331892010" sldId="257"/>
            <ac:spMk id="8" creationId="{32C2F818-16B9-B1AA-9AE3-18AB9AA617B3}"/>
          </ac:spMkLst>
        </pc:spChg>
        <pc:spChg chg="add mod">
          <ac:chgData name="Xu, Jin" userId="d0df0faf-f7e8-46e3-af8b-ed9c0c8d920b" providerId="ADAL" clId="{1690BDD1-8C68-EF46-A401-245660F0AAA3}" dt="2022-09-02T06:56:42.370" v="127" actId="20577"/>
          <ac:spMkLst>
            <pc:docMk/>
            <pc:sldMk cId="331892010" sldId="257"/>
            <ac:spMk id="9" creationId="{EC1F06DB-75BA-CCCB-F626-8157EE414BAF}"/>
          </ac:spMkLst>
        </pc:spChg>
        <pc:grpChg chg="add">
          <ac:chgData name="Xu, Jin" userId="d0df0faf-f7e8-46e3-af8b-ed9c0c8d920b" providerId="ADAL" clId="{1690BDD1-8C68-EF46-A401-245660F0AAA3}" dt="2022-09-02T06:56:51.497" v="128" actId="164"/>
          <ac:grpSpMkLst>
            <pc:docMk/>
            <pc:sldMk cId="331892010" sldId="257"/>
            <ac:grpSpMk id="10" creationId="{03FCB3E5-A266-FA19-BC03-15911AFDD15B}"/>
          </ac:grpSpMkLst>
        </pc:grpChg>
        <pc:picChg chg="del">
          <ac:chgData name="Xu, Jin" userId="d0df0faf-f7e8-46e3-af8b-ed9c0c8d920b" providerId="ADAL" clId="{1690BDD1-8C68-EF46-A401-245660F0AAA3}" dt="2022-09-02T06:55:29.238" v="110" actId="478"/>
          <ac:picMkLst>
            <pc:docMk/>
            <pc:sldMk cId="331892010" sldId="257"/>
            <ac:picMk id="2" creationId="{8AB2A196-6F12-46D9-86F1-51CC79263F27}"/>
          </ac:picMkLst>
        </pc:picChg>
        <pc:picChg chg="add mod">
          <ac:chgData name="Xu, Jin" userId="d0df0faf-f7e8-46e3-af8b-ed9c0c8d920b" providerId="ADAL" clId="{1690BDD1-8C68-EF46-A401-245660F0AAA3}" dt="2022-09-02T06:56:24.522" v="122" actId="1076"/>
          <ac:picMkLst>
            <pc:docMk/>
            <pc:sldMk cId="331892010" sldId="257"/>
            <ac:picMk id="5" creationId="{4A0D561C-E5D2-C784-7BCF-E9113038433C}"/>
          </ac:picMkLst>
        </pc:picChg>
        <pc:picChg chg="add mod">
          <ac:chgData name="Xu, Jin" userId="d0df0faf-f7e8-46e3-af8b-ed9c0c8d920b" providerId="ADAL" clId="{1690BDD1-8C68-EF46-A401-245660F0AAA3}" dt="2022-09-02T06:56:22.227" v="121" actId="1076"/>
          <ac:picMkLst>
            <pc:docMk/>
            <pc:sldMk cId="331892010" sldId="257"/>
            <ac:picMk id="7" creationId="{64C346AE-875E-37AE-54B9-2CEF8C05C3D2}"/>
          </ac:picMkLst>
        </pc:picChg>
      </pc:sldChg>
      <pc:sldChg chg="addSp delSp modSp mod">
        <pc:chgData name="Xu, Jin" userId="d0df0faf-f7e8-46e3-af8b-ed9c0c8d920b" providerId="ADAL" clId="{1690BDD1-8C68-EF46-A401-245660F0AAA3}" dt="2022-09-02T06:58:12.364" v="149" actId="1076"/>
        <pc:sldMkLst>
          <pc:docMk/>
          <pc:sldMk cId="1171582034" sldId="258"/>
        </pc:sldMkLst>
        <pc:spChg chg="mod">
          <ac:chgData name="Xu, Jin" userId="d0df0faf-f7e8-46e3-af8b-ed9c0c8d920b" providerId="ADAL" clId="{1690BDD1-8C68-EF46-A401-245660F0AAA3}" dt="2022-09-02T06:57:32.346" v="140" actId="1076"/>
          <ac:spMkLst>
            <pc:docMk/>
            <pc:sldMk cId="1171582034" sldId="258"/>
            <ac:spMk id="3" creationId="{C604082E-BB76-4110-8FE5-38EF668D6113}"/>
          </ac:spMkLst>
        </pc:spChg>
        <pc:picChg chg="del">
          <ac:chgData name="Xu, Jin" userId="d0df0faf-f7e8-46e3-af8b-ed9c0c8d920b" providerId="ADAL" clId="{1690BDD1-8C68-EF46-A401-245660F0AAA3}" dt="2022-09-02T06:57:33.491" v="141" actId="478"/>
          <ac:picMkLst>
            <pc:docMk/>
            <pc:sldMk cId="1171582034" sldId="258"/>
            <ac:picMk id="2" creationId="{89B28A36-7B98-4994-B989-01B8C325CE7F}"/>
          </ac:picMkLst>
        </pc:picChg>
        <pc:picChg chg="add mod">
          <ac:chgData name="Xu, Jin" userId="d0df0faf-f7e8-46e3-af8b-ed9c0c8d920b" providerId="ADAL" clId="{1690BDD1-8C68-EF46-A401-245660F0AAA3}" dt="2022-09-02T06:58:12.364" v="149" actId="1076"/>
          <ac:picMkLst>
            <pc:docMk/>
            <pc:sldMk cId="1171582034" sldId="258"/>
            <ac:picMk id="5" creationId="{3216D703-BAF5-1B09-02CD-4720B2894DD6}"/>
          </ac:picMkLst>
        </pc:picChg>
      </pc:sldChg>
      <pc:sldChg chg="addSp delSp modSp new mod">
        <pc:chgData name="Xu, Jin" userId="d0df0faf-f7e8-46e3-af8b-ed9c0c8d920b" providerId="ADAL" clId="{1690BDD1-8C68-EF46-A401-245660F0AAA3}" dt="2022-09-02T06:54:26.618" v="89" actId="164"/>
        <pc:sldMkLst>
          <pc:docMk/>
          <pc:sldMk cId="2738703141" sldId="259"/>
        </pc:sldMkLst>
        <pc:spChg chg="add mod">
          <ac:chgData name="Xu, Jin" userId="d0df0faf-f7e8-46e3-af8b-ed9c0c8d920b" providerId="ADAL" clId="{1690BDD1-8C68-EF46-A401-245660F0AAA3}" dt="2022-09-02T06:52:36.265" v="65" actId="20577"/>
          <ac:spMkLst>
            <pc:docMk/>
            <pc:sldMk cId="2738703141" sldId="259"/>
            <ac:spMk id="2" creationId="{7CD5CB1D-50C1-935B-81B9-0251786A770F}"/>
          </ac:spMkLst>
        </pc:spChg>
        <pc:spChg chg="add del">
          <ac:chgData name="Xu, Jin" userId="d0df0faf-f7e8-46e3-af8b-ed9c0c8d920b" providerId="ADAL" clId="{1690BDD1-8C68-EF46-A401-245660F0AAA3}" dt="2022-09-02T06:53:53.741" v="84" actId="478"/>
          <ac:spMkLst>
            <pc:docMk/>
            <pc:sldMk cId="2738703141" sldId="259"/>
            <ac:spMk id="8" creationId="{3931069C-3CCE-1FD0-20C5-1EF36D1D5851}"/>
          </ac:spMkLst>
        </pc:spChg>
        <pc:spChg chg="add mod">
          <ac:chgData name="Xu, Jin" userId="d0df0faf-f7e8-46e3-af8b-ed9c0c8d920b" providerId="ADAL" clId="{1690BDD1-8C68-EF46-A401-245660F0AAA3}" dt="2022-09-02T06:53:59.778" v="85"/>
          <ac:spMkLst>
            <pc:docMk/>
            <pc:sldMk cId="2738703141" sldId="259"/>
            <ac:spMk id="9" creationId="{6289AA58-19ED-EFBC-D767-B34F94F55AE5}"/>
          </ac:spMkLst>
        </pc:spChg>
        <pc:spChg chg="add mod">
          <ac:chgData name="Xu, Jin" userId="d0df0faf-f7e8-46e3-af8b-ed9c0c8d920b" providerId="ADAL" clId="{1690BDD1-8C68-EF46-A401-245660F0AAA3}" dt="2022-09-02T06:54:09.844" v="88" actId="20577"/>
          <ac:spMkLst>
            <pc:docMk/>
            <pc:sldMk cId="2738703141" sldId="259"/>
            <ac:spMk id="10" creationId="{83541831-C0FB-EB36-B927-4EDE59BA63F2}"/>
          </ac:spMkLst>
        </pc:spChg>
        <pc:grpChg chg="add">
          <ac:chgData name="Xu, Jin" userId="d0df0faf-f7e8-46e3-af8b-ed9c0c8d920b" providerId="ADAL" clId="{1690BDD1-8C68-EF46-A401-245660F0AAA3}" dt="2022-09-02T06:54:26.618" v="89" actId="164"/>
          <ac:grpSpMkLst>
            <pc:docMk/>
            <pc:sldMk cId="2738703141" sldId="259"/>
            <ac:grpSpMk id="11" creationId="{8C8DD245-F2DE-CCCC-9508-1138889EBF59}"/>
          </ac:grpSpMkLst>
        </pc:grpChg>
        <pc:picChg chg="add mod">
          <ac:chgData name="Xu, Jin" userId="d0df0faf-f7e8-46e3-af8b-ed9c0c8d920b" providerId="ADAL" clId="{1690BDD1-8C68-EF46-A401-245660F0AAA3}" dt="2022-09-02T06:53:38.678" v="81" actId="1076"/>
          <ac:picMkLst>
            <pc:docMk/>
            <pc:sldMk cId="2738703141" sldId="259"/>
            <ac:picMk id="4" creationId="{F263F8EA-9465-3531-28D3-B730D8384A9F}"/>
          </ac:picMkLst>
        </pc:picChg>
        <pc:picChg chg="add mod">
          <ac:chgData name="Xu, Jin" userId="d0df0faf-f7e8-46e3-af8b-ed9c0c8d920b" providerId="ADAL" clId="{1690BDD1-8C68-EF46-A401-245660F0AAA3}" dt="2022-09-02T06:53:41.250" v="82" actId="1076"/>
          <ac:picMkLst>
            <pc:docMk/>
            <pc:sldMk cId="2738703141" sldId="259"/>
            <ac:picMk id="6" creationId="{093FC153-48C8-FEA4-9BC1-0C8BD9E50750}"/>
          </ac:picMkLst>
        </pc:picChg>
      </pc:sldChg>
    </pc:docChg>
  </pc:docChgLst>
  <pc:docChgLst>
    <pc:chgData name="Xu, Jin" userId="d0df0faf-f7e8-46e3-af8b-ed9c0c8d920b" providerId="ADAL" clId="{7816DD1C-8DFC-3E49-9879-A5427840CE1C}"/>
    <pc:docChg chg="modSld">
      <pc:chgData name="Xu, Jin" userId="d0df0faf-f7e8-46e3-af8b-ed9c0c8d920b" providerId="ADAL" clId="{7816DD1C-8DFC-3E49-9879-A5427840CE1C}" dt="2022-08-05T10:59:45.677" v="25" actId="20577"/>
      <pc:docMkLst>
        <pc:docMk/>
      </pc:docMkLst>
      <pc:sldChg chg="modSp mod">
        <pc:chgData name="Xu, Jin" userId="d0df0faf-f7e8-46e3-af8b-ed9c0c8d920b" providerId="ADAL" clId="{7816DD1C-8DFC-3E49-9879-A5427840CE1C}" dt="2022-08-05T10:59:35.806" v="24" actId="20577"/>
        <pc:sldMkLst>
          <pc:docMk/>
          <pc:sldMk cId="3959288222" sldId="256"/>
        </pc:sldMkLst>
        <pc:spChg chg="mod">
          <ac:chgData name="Xu, Jin" userId="d0df0faf-f7e8-46e3-af8b-ed9c0c8d920b" providerId="ADAL" clId="{7816DD1C-8DFC-3E49-9879-A5427840CE1C}" dt="2022-08-05T10:59:35.806" v="24" actId="20577"/>
          <ac:spMkLst>
            <pc:docMk/>
            <pc:sldMk cId="3959288222" sldId="256"/>
            <ac:spMk id="5" creationId="{9C3FBBB3-35B4-414F-8BEA-E77B2E1F8A75}"/>
          </ac:spMkLst>
        </pc:spChg>
      </pc:sldChg>
      <pc:sldChg chg="modSp mod">
        <pc:chgData name="Xu, Jin" userId="d0df0faf-f7e8-46e3-af8b-ed9c0c8d920b" providerId="ADAL" clId="{7816DD1C-8DFC-3E49-9879-A5427840CE1C}" dt="2022-08-05T10:59:45.677" v="25" actId="20577"/>
        <pc:sldMkLst>
          <pc:docMk/>
          <pc:sldMk cId="331892010" sldId="257"/>
        </pc:sldMkLst>
        <pc:spChg chg="mod">
          <ac:chgData name="Xu, Jin" userId="d0df0faf-f7e8-46e3-af8b-ed9c0c8d920b" providerId="ADAL" clId="{7816DD1C-8DFC-3E49-9879-A5427840CE1C}" dt="2022-08-05T10:59:45.677" v="25" actId="20577"/>
          <ac:spMkLst>
            <pc:docMk/>
            <pc:sldMk cId="331892010" sldId="257"/>
            <ac:spMk id="3" creationId="{D64A9041-ECAD-4673-8026-FAABEEFB697D}"/>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04ADB2-AF12-4142-AE05-CBC315655C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6D58D3B1-E183-4D06-8E00-D7BCF2E2C23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A7F5362-F205-4920-87CC-C96618F52C66}"/>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57AC7731-0BFD-4E6F-AD7D-2B88AEE2748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82D703D-DCCF-45C8-BC4C-1145E8466F9C}"/>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8531737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C24D0-139C-41F3-AC95-F674137FFA57}"/>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FDE7D98-D1AE-4DB0-B5CD-83420CB613A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14FF400-823C-4E23-8A73-EA78F8AA1FD8}"/>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B8D913CB-D04E-407F-AED5-ECBFB61E956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EF749E0-8785-4512-9488-8C4D89474F5D}"/>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24690338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1E570F6-1A36-4F54-924F-CD7882E3836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F66654C3-4831-4055-AD24-C238808C5ED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B3425F1-0E29-4C89-8699-E351B1C502C9}"/>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3893B7B0-4F7F-441E-A7ED-273733A50A4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F10F4B8-F412-4A16-A753-E1E021C4DA1A}"/>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36058663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556A06-D6E6-4643-8D60-EDAAE93F8403}"/>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5311BF01-824F-4897-93E8-A78ECC16518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A8343C9-C92E-483A-B6E0-2B01B2072080}"/>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4B63F1CB-7D53-4219-99CC-EA6616AACC0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3284087-DAC3-4334-8172-D6855C11738E}"/>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14588907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F49A48-AFD0-400B-B226-A2F6D25F206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E17778FA-4DB4-42A8-8994-771169112DD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AB9EC06-0E37-4A30-8A7D-2DC726632F7F}"/>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6D736B13-48A8-4180-8548-8FAA182B451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119BE69-E42D-4F54-A0D6-6E71C677C948}"/>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36244974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93076C-DA1C-4F79-836C-17D640C11550}"/>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AD02B6F7-6D63-43E0-A547-64CD84F8CD7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B0737420-A9B6-4629-9C72-978E592FFAF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5AC385BA-30A5-4210-82A9-12932B8C9D0E}"/>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6" name="Footer Placeholder 5">
            <a:extLst>
              <a:ext uri="{FF2B5EF4-FFF2-40B4-BE49-F238E27FC236}">
                <a16:creationId xmlns:a16="http://schemas.microsoft.com/office/drawing/2014/main" id="{211C7F3F-7CB9-4631-AF57-6D4E1D96229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954CBA2-99A9-45F1-98A9-5755DCD03AA2}"/>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14637778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E91518-67BF-4D32-8F1D-27066B53538C}"/>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4E206BE0-8BC2-4FC5-AFD7-672F0F33638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5FE3324-D426-46A5-A9B5-46FA9257883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5B5FA335-2DF6-4096-BD4B-B5F4CFC3C6E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A8EE1B7-097D-4447-820C-0B714C05230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B2A4B939-112E-4C1B-B2D2-7D370A9437D7}"/>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8" name="Footer Placeholder 7">
            <a:extLst>
              <a:ext uri="{FF2B5EF4-FFF2-40B4-BE49-F238E27FC236}">
                <a16:creationId xmlns:a16="http://schemas.microsoft.com/office/drawing/2014/main" id="{5DF4EAAF-793C-40A9-9F99-E99798A501CE}"/>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E5BDBB1C-C13D-43F6-A6A0-2FE93273C7E6}"/>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3193029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82EAA1-BAB6-4039-889C-62EA9AF937AA}"/>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874A9F6F-B63C-47B3-871E-5AC60B5467A5}"/>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4" name="Footer Placeholder 3">
            <a:extLst>
              <a:ext uri="{FF2B5EF4-FFF2-40B4-BE49-F238E27FC236}">
                <a16:creationId xmlns:a16="http://schemas.microsoft.com/office/drawing/2014/main" id="{E6ED3A2A-EEF9-4FFF-9321-5AAF0F5FA387}"/>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C562F948-C0B6-4D17-81D4-01413A4617A5}"/>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39236454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179CB77-F9DF-4504-9F0C-66D9CA3FBCC4}"/>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3" name="Footer Placeholder 2">
            <a:extLst>
              <a:ext uri="{FF2B5EF4-FFF2-40B4-BE49-F238E27FC236}">
                <a16:creationId xmlns:a16="http://schemas.microsoft.com/office/drawing/2014/main" id="{59918A60-6A1C-4BE7-9887-25F21BC88C94}"/>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FBF664D8-6BF6-4D1A-9575-604C541A08D8}"/>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35043864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CE971B-10C6-41A3-9904-5D61C42D14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6E1BB9CF-14A4-427F-9B46-80F63A47718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20F779D2-43D0-49A6-AE2D-E85B682515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DA4A74E-EE95-4653-81CD-5C5BFD620830}"/>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6" name="Footer Placeholder 5">
            <a:extLst>
              <a:ext uri="{FF2B5EF4-FFF2-40B4-BE49-F238E27FC236}">
                <a16:creationId xmlns:a16="http://schemas.microsoft.com/office/drawing/2014/main" id="{050D4FD0-618E-44E0-9289-22985186EA02}"/>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40684FE-71D9-487A-AF9E-B64F5806650A}"/>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26365110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525033-34EC-4F82-8429-E8FC3C9BE5B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871A4BD-3C68-4C70-9E68-707E86FFFC8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F95F0ED-F320-4157-9D40-381D1D3EA4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F75F25-1B59-4ED8-BC8D-694D1E6A66F0}"/>
              </a:ext>
            </a:extLst>
          </p:cNvPr>
          <p:cNvSpPr>
            <a:spLocks noGrp="1"/>
          </p:cNvSpPr>
          <p:nvPr>
            <p:ph type="dt" sz="half" idx="10"/>
          </p:nvPr>
        </p:nvSpPr>
        <p:spPr/>
        <p:txBody>
          <a:bodyPr/>
          <a:lstStyle/>
          <a:p>
            <a:fld id="{63566AD6-7EDB-41E9-A468-2D54B426F5A3}" type="datetimeFigureOut">
              <a:rPr lang="en-GB" smtClean="0"/>
              <a:t>02/09/2022</a:t>
            </a:fld>
            <a:endParaRPr lang="en-GB"/>
          </a:p>
        </p:txBody>
      </p:sp>
      <p:sp>
        <p:nvSpPr>
          <p:cNvPr id="6" name="Footer Placeholder 5">
            <a:extLst>
              <a:ext uri="{FF2B5EF4-FFF2-40B4-BE49-F238E27FC236}">
                <a16:creationId xmlns:a16="http://schemas.microsoft.com/office/drawing/2014/main" id="{66646F8C-E24B-458D-8764-0C5500A992E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CE9FE58-276B-4134-AB9A-CE1A45558900}"/>
              </a:ext>
            </a:extLst>
          </p:cNvPr>
          <p:cNvSpPr>
            <a:spLocks noGrp="1"/>
          </p:cNvSpPr>
          <p:nvPr>
            <p:ph type="sldNum" sz="quarter" idx="12"/>
          </p:nvPr>
        </p:nvSpPr>
        <p:spPr/>
        <p:txBody>
          <a:bodyPr/>
          <a:lstStyle/>
          <a:p>
            <a:fld id="{96228E65-4287-48D2-8CED-3CFABBF9DDCB}" type="slidenum">
              <a:rPr lang="en-GB" smtClean="0"/>
              <a:t>‹#›</a:t>
            </a:fld>
            <a:endParaRPr lang="en-GB"/>
          </a:p>
        </p:txBody>
      </p:sp>
    </p:spTree>
    <p:extLst>
      <p:ext uri="{BB962C8B-B14F-4D97-AF65-F5344CB8AC3E}">
        <p14:creationId xmlns:p14="http://schemas.microsoft.com/office/powerpoint/2010/main" val="27445080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4A55B2B-F508-40CB-889F-B4D35902C40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F14DD254-156D-4551-8790-031DDD4B7AE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AA6A3B3-9162-4B14-88D5-CD3166566D3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566AD6-7EDB-41E9-A468-2D54B426F5A3}" type="datetimeFigureOut">
              <a:rPr lang="en-GB" smtClean="0"/>
              <a:t>02/09/2022</a:t>
            </a:fld>
            <a:endParaRPr lang="en-GB"/>
          </a:p>
        </p:txBody>
      </p:sp>
      <p:sp>
        <p:nvSpPr>
          <p:cNvPr id="5" name="Footer Placeholder 4">
            <a:extLst>
              <a:ext uri="{FF2B5EF4-FFF2-40B4-BE49-F238E27FC236}">
                <a16:creationId xmlns:a16="http://schemas.microsoft.com/office/drawing/2014/main" id="{291B95C2-3EFC-48BE-B974-09AB675126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D5B82999-44BD-4477-8827-4465DC1DAD2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228E65-4287-48D2-8CED-3CFABBF9DDCB}" type="slidenum">
              <a:rPr lang="en-GB" smtClean="0"/>
              <a:t>‹#›</a:t>
            </a:fld>
            <a:endParaRPr lang="en-GB"/>
          </a:p>
        </p:txBody>
      </p:sp>
    </p:spTree>
    <p:extLst>
      <p:ext uri="{BB962C8B-B14F-4D97-AF65-F5344CB8AC3E}">
        <p14:creationId xmlns:p14="http://schemas.microsoft.com/office/powerpoint/2010/main" val="27690590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C3FBBB3-35B4-414F-8BEA-E77B2E1F8A75}"/>
              </a:ext>
            </a:extLst>
          </p:cNvPr>
          <p:cNvSpPr txBox="1"/>
          <p:nvPr/>
        </p:nvSpPr>
        <p:spPr>
          <a:xfrm>
            <a:off x="622516" y="5416605"/>
            <a:ext cx="11039393" cy="923330"/>
          </a:xfrm>
          <a:prstGeom prst="rect">
            <a:avLst/>
          </a:prstGeom>
          <a:noFill/>
        </p:spPr>
        <p:txBody>
          <a:bodyPr wrap="square" rtlCol="0">
            <a:spAutoFit/>
          </a:bodyPr>
          <a:lstStyle/>
          <a:p>
            <a:r>
              <a:rPr lang="en-GB" b="0" i="0" u="none" strike="noStrike" dirty="0">
                <a:solidFill>
                  <a:srgbClr val="000000"/>
                </a:solidFill>
                <a:effectLst/>
                <a:latin typeface="Times New Roman" panose="02020603050405020304" pitchFamily="18" charset="0"/>
              </a:rPr>
              <a:t>Fig 1S. Scatterplots of the gene-biomarker versus gene-AD associations when AD is the exposure and biomarkers (A) RCN2 and (B) Sphingomyelins are the outcome in  MR analyses. Each point in the scatter plot represents an instrumental SNP and different regression lines represents the different MR methods used.</a:t>
            </a:r>
            <a:r>
              <a:rPr lang="en-GB" dirty="0"/>
              <a:t> </a:t>
            </a:r>
          </a:p>
        </p:txBody>
      </p:sp>
      <p:grpSp>
        <p:nvGrpSpPr>
          <p:cNvPr id="10" name="Group 9">
            <a:extLst>
              <a:ext uri="{FF2B5EF4-FFF2-40B4-BE49-F238E27FC236}">
                <a16:creationId xmlns:a16="http://schemas.microsoft.com/office/drawing/2014/main" id="{C1D72D68-34A3-4F79-3D54-D24EC943C4A2}"/>
              </a:ext>
            </a:extLst>
          </p:cNvPr>
          <p:cNvGrpSpPr/>
          <p:nvPr/>
        </p:nvGrpSpPr>
        <p:grpSpPr>
          <a:xfrm>
            <a:off x="304800" y="454716"/>
            <a:ext cx="11357110" cy="4456227"/>
            <a:chOff x="304800" y="454716"/>
            <a:chExt cx="11357110" cy="4456227"/>
          </a:xfrm>
        </p:grpSpPr>
        <p:pic>
          <p:nvPicPr>
            <p:cNvPr id="3" name="Picture 2">
              <a:extLst>
                <a:ext uri="{FF2B5EF4-FFF2-40B4-BE49-F238E27FC236}">
                  <a16:creationId xmlns:a16="http://schemas.microsoft.com/office/drawing/2014/main" id="{67C1DF23-B332-F557-C99E-C7059AEABB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6074" y="455058"/>
              <a:ext cx="5175368" cy="4455885"/>
            </a:xfrm>
            <a:prstGeom prst="rect">
              <a:avLst/>
            </a:prstGeom>
          </p:spPr>
        </p:pic>
        <p:pic>
          <p:nvPicPr>
            <p:cNvPr id="7" name="Picture 6">
              <a:extLst>
                <a:ext uri="{FF2B5EF4-FFF2-40B4-BE49-F238E27FC236}">
                  <a16:creationId xmlns:a16="http://schemas.microsoft.com/office/drawing/2014/main" id="{CCB5E968-09EB-74D0-3817-1B8B8CA45C3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86542" y="454716"/>
              <a:ext cx="5175368" cy="4455885"/>
            </a:xfrm>
            <a:prstGeom prst="rect">
              <a:avLst/>
            </a:prstGeom>
          </p:spPr>
        </p:pic>
        <p:sp>
          <p:nvSpPr>
            <p:cNvPr id="8" name="TextBox 7">
              <a:extLst>
                <a:ext uri="{FF2B5EF4-FFF2-40B4-BE49-F238E27FC236}">
                  <a16:creationId xmlns:a16="http://schemas.microsoft.com/office/drawing/2014/main" id="{5B64F5DD-FBA7-9403-0BDB-E05105542B05}"/>
                </a:ext>
              </a:extLst>
            </p:cNvPr>
            <p:cNvSpPr txBox="1"/>
            <p:nvPr/>
          </p:nvSpPr>
          <p:spPr>
            <a:xfrm>
              <a:off x="304800" y="556591"/>
              <a:ext cx="31771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37A78822-335E-3D9C-DBD6-5C3CC159DE88}"/>
                </a:ext>
              </a:extLst>
            </p:cNvPr>
            <p:cNvSpPr txBox="1"/>
            <p:nvPr/>
          </p:nvSpPr>
          <p:spPr>
            <a:xfrm>
              <a:off x="6327684" y="549965"/>
              <a:ext cx="309700" cy="369332"/>
            </a:xfrm>
            <a:prstGeom prst="rect">
              <a:avLst/>
            </a:prstGeom>
            <a:noFill/>
          </p:spPr>
          <p:txBody>
            <a:bodyPr wrap="none" rtlCol="0">
              <a:spAutoFit/>
            </a:bodyPr>
            <a:lstStyle/>
            <a:p>
              <a:r>
                <a:rPr lang="en-US" dirty="0"/>
                <a:t>B</a:t>
              </a:r>
            </a:p>
          </p:txBody>
        </p:sp>
      </p:grpSp>
    </p:spTree>
    <p:extLst>
      <p:ext uri="{BB962C8B-B14F-4D97-AF65-F5344CB8AC3E}">
        <p14:creationId xmlns:p14="http://schemas.microsoft.com/office/powerpoint/2010/main" val="39592882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CD5CB1D-50C1-935B-81B9-0251786A770F}"/>
              </a:ext>
            </a:extLst>
          </p:cNvPr>
          <p:cNvSpPr txBox="1"/>
          <p:nvPr/>
        </p:nvSpPr>
        <p:spPr>
          <a:xfrm>
            <a:off x="622516" y="5416605"/>
            <a:ext cx="11039393" cy="646331"/>
          </a:xfrm>
          <a:prstGeom prst="rect">
            <a:avLst/>
          </a:prstGeom>
          <a:noFill/>
        </p:spPr>
        <p:txBody>
          <a:bodyPr wrap="square" rtlCol="0">
            <a:spAutoFit/>
          </a:bodyPr>
          <a:lstStyle/>
          <a:p>
            <a:r>
              <a:rPr lang="en-GB" b="0" i="0" u="none" strike="noStrike" dirty="0">
                <a:solidFill>
                  <a:srgbClr val="000000"/>
                </a:solidFill>
                <a:effectLst/>
                <a:latin typeface="Times New Roman" panose="02020603050405020304" pitchFamily="18" charset="0"/>
              </a:rPr>
              <a:t>Fig 2S. Leave-one-out (LOO) plots when AD is the exposure and biomarkers (A) RCN2 and (B) Sphingomyelins are the outcome following univariable MR analyses.</a:t>
            </a:r>
            <a:r>
              <a:rPr lang="en-GB" dirty="0"/>
              <a:t> </a:t>
            </a:r>
          </a:p>
        </p:txBody>
      </p:sp>
      <p:grpSp>
        <p:nvGrpSpPr>
          <p:cNvPr id="11" name="Group 10">
            <a:extLst>
              <a:ext uri="{FF2B5EF4-FFF2-40B4-BE49-F238E27FC236}">
                <a16:creationId xmlns:a16="http://schemas.microsoft.com/office/drawing/2014/main" id="{8C8DD245-F2DE-CCCC-9508-1138889EBF59}"/>
              </a:ext>
            </a:extLst>
          </p:cNvPr>
          <p:cNvGrpSpPr/>
          <p:nvPr/>
        </p:nvGrpSpPr>
        <p:grpSpPr>
          <a:xfrm>
            <a:off x="304800" y="556591"/>
            <a:ext cx="11572106" cy="4724177"/>
            <a:chOff x="304800" y="556591"/>
            <a:chExt cx="11572106" cy="4724177"/>
          </a:xfrm>
        </p:grpSpPr>
        <p:pic>
          <p:nvPicPr>
            <p:cNvPr id="4" name="Picture 3">
              <a:extLst>
                <a:ext uri="{FF2B5EF4-FFF2-40B4-BE49-F238E27FC236}">
                  <a16:creationId xmlns:a16="http://schemas.microsoft.com/office/drawing/2014/main" id="{F263F8EA-9465-3531-28D3-B730D8384A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2516" y="709339"/>
              <a:ext cx="5309568" cy="4571429"/>
            </a:xfrm>
            <a:prstGeom prst="rect">
              <a:avLst/>
            </a:prstGeom>
          </p:spPr>
        </p:pic>
        <p:pic>
          <p:nvPicPr>
            <p:cNvPr id="6" name="Picture 5">
              <a:extLst>
                <a:ext uri="{FF2B5EF4-FFF2-40B4-BE49-F238E27FC236}">
                  <a16:creationId xmlns:a16="http://schemas.microsoft.com/office/drawing/2014/main" id="{093FC153-48C8-FEA4-9BC1-0C8BD9E5075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67340" y="709339"/>
              <a:ext cx="5309566" cy="4571428"/>
            </a:xfrm>
            <a:prstGeom prst="rect">
              <a:avLst/>
            </a:prstGeom>
          </p:spPr>
        </p:pic>
        <p:sp>
          <p:nvSpPr>
            <p:cNvPr id="9" name="TextBox 8">
              <a:extLst>
                <a:ext uri="{FF2B5EF4-FFF2-40B4-BE49-F238E27FC236}">
                  <a16:creationId xmlns:a16="http://schemas.microsoft.com/office/drawing/2014/main" id="{6289AA58-19ED-EFBC-D767-B34F94F55AE5}"/>
                </a:ext>
              </a:extLst>
            </p:cNvPr>
            <p:cNvSpPr txBox="1"/>
            <p:nvPr/>
          </p:nvSpPr>
          <p:spPr>
            <a:xfrm>
              <a:off x="304800" y="556591"/>
              <a:ext cx="317716"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83541831-C0FB-EB36-B927-4EDE59BA63F2}"/>
                </a:ext>
              </a:extLst>
            </p:cNvPr>
            <p:cNvSpPr txBox="1"/>
            <p:nvPr/>
          </p:nvSpPr>
          <p:spPr>
            <a:xfrm>
              <a:off x="6307247" y="556591"/>
              <a:ext cx="317716" cy="369332"/>
            </a:xfrm>
            <a:prstGeom prst="rect">
              <a:avLst/>
            </a:prstGeom>
            <a:noFill/>
          </p:spPr>
          <p:txBody>
            <a:bodyPr wrap="none" rtlCol="0">
              <a:spAutoFit/>
            </a:bodyPr>
            <a:lstStyle/>
            <a:p>
              <a:r>
                <a:rPr lang="en-US" dirty="0"/>
                <a:t>B</a:t>
              </a:r>
            </a:p>
          </p:txBody>
        </p:sp>
      </p:grpSp>
    </p:spTree>
    <p:extLst>
      <p:ext uri="{BB962C8B-B14F-4D97-AF65-F5344CB8AC3E}">
        <p14:creationId xmlns:p14="http://schemas.microsoft.com/office/powerpoint/2010/main" val="2738703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64A9041-ECAD-4673-8026-FAABEEFB697D}"/>
              </a:ext>
            </a:extLst>
          </p:cNvPr>
          <p:cNvSpPr txBox="1"/>
          <p:nvPr/>
        </p:nvSpPr>
        <p:spPr>
          <a:xfrm>
            <a:off x="616226" y="5767257"/>
            <a:ext cx="10959548" cy="646331"/>
          </a:xfrm>
          <a:prstGeom prst="rect">
            <a:avLst/>
          </a:prstGeom>
          <a:noFill/>
        </p:spPr>
        <p:txBody>
          <a:bodyPr wrap="square" rtlCol="0">
            <a:spAutoFit/>
          </a:bodyPr>
          <a:lstStyle/>
          <a:p>
            <a:r>
              <a:rPr lang="en-GB" dirty="0"/>
              <a:t>Figure S3. </a:t>
            </a:r>
            <a:r>
              <a:rPr lang="en-GB" b="0" i="0" u="none" strike="noStrike" dirty="0">
                <a:solidFill>
                  <a:srgbClr val="000000"/>
                </a:solidFill>
                <a:effectLst/>
                <a:latin typeface="Times New Roman" panose="02020603050405020304" pitchFamily="18" charset="0"/>
              </a:rPr>
              <a:t>Fig. 3 Funnel plots when AD is the exposure and biomarkers (A) RCN2 and (B) Sphingomyelins are the outcome following univariable MR analyses.</a:t>
            </a:r>
            <a:r>
              <a:rPr lang="en-GB" dirty="0"/>
              <a:t> </a:t>
            </a:r>
          </a:p>
        </p:txBody>
      </p:sp>
      <p:grpSp>
        <p:nvGrpSpPr>
          <p:cNvPr id="10" name="Group 9">
            <a:extLst>
              <a:ext uri="{FF2B5EF4-FFF2-40B4-BE49-F238E27FC236}">
                <a16:creationId xmlns:a16="http://schemas.microsoft.com/office/drawing/2014/main" id="{03FCB3E5-A266-FA19-BC03-15911AFDD15B}"/>
              </a:ext>
            </a:extLst>
          </p:cNvPr>
          <p:cNvGrpSpPr/>
          <p:nvPr/>
        </p:nvGrpSpPr>
        <p:grpSpPr>
          <a:xfrm>
            <a:off x="225287" y="556591"/>
            <a:ext cx="11741427" cy="4910160"/>
            <a:chOff x="225287" y="556591"/>
            <a:chExt cx="11741427" cy="4910160"/>
          </a:xfrm>
        </p:grpSpPr>
        <p:pic>
          <p:nvPicPr>
            <p:cNvPr id="5" name="Picture 4">
              <a:extLst>
                <a:ext uri="{FF2B5EF4-FFF2-40B4-BE49-F238E27FC236}">
                  <a16:creationId xmlns:a16="http://schemas.microsoft.com/office/drawing/2014/main" id="{4A0D561C-E5D2-C784-7BCF-E9113038433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5287" y="634339"/>
              <a:ext cx="5612691" cy="4832412"/>
            </a:xfrm>
            <a:prstGeom prst="rect">
              <a:avLst/>
            </a:prstGeom>
          </p:spPr>
        </p:pic>
        <p:pic>
          <p:nvPicPr>
            <p:cNvPr id="7" name="Picture 6">
              <a:extLst>
                <a:ext uri="{FF2B5EF4-FFF2-40B4-BE49-F238E27FC236}">
                  <a16:creationId xmlns:a16="http://schemas.microsoft.com/office/drawing/2014/main" id="{64C346AE-875E-37AE-54B9-2CEF8C05C3D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54023" y="634339"/>
              <a:ext cx="5612691" cy="4832412"/>
            </a:xfrm>
            <a:prstGeom prst="rect">
              <a:avLst/>
            </a:prstGeom>
          </p:spPr>
        </p:pic>
        <p:sp>
          <p:nvSpPr>
            <p:cNvPr id="8" name="TextBox 7">
              <a:extLst>
                <a:ext uri="{FF2B5EF4-FFF2-40B4-BE49-F238E27FC236}">
                  <a16:creationId xmlns:a16="http://schemas.microsoft.com/office/drawing/2014/main" id="{32C2F818-16B9-B1AA-9AE3-18AB9AA617B3}"/>
                </a:ext>
              </a:extLst>
            </p:cNvPr>
            <p:cNvSpPr txBox="1"/>
            <p:nvPr/>
          </p:nvSpPr>
          <p:spPr>
            <a:xfrm>
              <a:off x="304800" y="556591"/>
              <a:ext cx="317716" cy="369332"/>
            </a:xfrm>
            <a:prstGeom prst="rect">
              <a:avLst/>
            </a:prstGeom>
            <a:noFill/>
          </p:spPr>
          <p:txBody>
            <a:bodyPr wrap="none" rtlCol="0">
              <a:spAutoFit/>
            </a:bodyPr>
            <a:lstStyle/>
            <a:p>
              <a:r>
                <a:rPr lang="en-US" dirty="0"/>
                <a:t>A</a:t>
              </a:r>
            </a:p>
          </p:txBody>
        </p:sp>
        <p:sp>
          <p:nvSpPr>
            <p:cNvPr id="9" name="TextBox 8">
              <a:extLst>
                <a:ext uri="{FF2B5EF4-FFF2-40B4-BE49-F238E27FC236}">
                  <a16:creationId xmlns:a16="http://schemas.microsoft.com/office/drawing/2014/main" id="{EC1F06DB-75BA-CCCB-F626-8157EE414BAF}"/>
                </a:ext>
              </a:extLst>
            </p:cNvPr>
            <p:cNvSpPr txBox="1"/>
            <p:nvPr/>
          </p:nvSpPr>
          <p:spPr>
            <a:xfrm>
              <a:off x="6195165" y="556591"/>
              <a:ext cx="309700" cy="369332"/>
            </a:xfrm>
            <a:prstGeom prst="rect">
              <a:avLst/>
            </a:prstGeom>
            <a:noFill/>
          </p:spPr>
          <p:txBody>
            <a:bodyPr wrap="none" rtlCol="0">
              <a:spAutoFit/>
            </a:bodyPr>
            <a:lstStyle/>
            <a:p>
              <a:r>
                <a:rPr lang="en-US" dirty="0"/>
                <a:t>B</a:t>
              </a:r>
            </a:p>
          </p:txBody>
        </p:sp>
      </p:grpSp>
    </p:spTree>
    <p:extLst>
      <p:ext uri="{BB962C8B-B14F-4D97-AF65-F5344CB8AC3E}">
        <p14:creationId xmlns:p14="http://schemas.microsoft.com/office/powerpoint/2010/main" val="3318920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604082E-BB76-4110-8FE5-38EF668D6113}"/>
              </a:ext>
            </a:extLst>
          </p:cNvPr>
          <p:cNvSpPr txBox="1"/>
          <p:nvPr/>
        </p:nvSpPr>
        <p:spPr>
          <a:xfrm>
            <a:off x="424069" y="5515466"/>
            <a:ext cx="11542643" cy="1200329"/>
          </a:xfrm>
          <a:prstGeom prst="rect">
            <a:avLst/>
          </a:prstGeom>
          <a:noFill/>
        </p:spPr>
        <p:txBody>
          <a:bodyPr wrap="square" rtlCol="0">
            <a:spAutoFit/>
          </a:bodyPr>
          <a:lstStyle/>
          <a:p>
            <a:r>
              <a:rPr lang="en-GB" dirty="0"/>
              <a:t>Figure S4. </a:t>
            </a:r>
            <a:r>
              <a:rPr lang="en-GB" b="0" i="0" u="none" strike="noStrike" dirty="0">
                <a:solidFill>
                  <a:srgbClr val="000000"/>
                </a:solidFill>
                <a:effectLst/>
                <a:latin typeface="Calibri" panose="020F0502020204030204" pitchFamily="34" charset="0"/>
              </a:rPr>
              <a:t> Scatterplots of the gene-AD vs gene-PCSK7 (Sun et al) </a:t>
            </a:r>
            <a:r>
              <a:rPr lang="en-GB" b="0" i="0" u="none" strike="noStrike" dirty="0" err="1">
                <a:solidFill>
                  <a:srgbClr val="000000"/>
                </a:solidFill>
                <a:effectLst/>
                <a:latin typeface="Calibri" panose="020F0502020204030204" pitchFamily="34" charset="0"/>
              </a:rPr>
              <a:t>associaitons</a:t>
            </a:r>
            <a:r>
              <a:rPr lang="en-GB" b="0" i="0" u="none" strike="noStrike" dirty="0">
                <a:solidFill>
                  <a:srgbClr val="000000"/>
                </a:solidFill>
                <a:effectLst/>
                <a:latin typeface="Calibri" panose="020F0502020204030204" pitchFamily="34" charset="0"/>
              </a:rPr>
              <a:t> when PCSK7 is the exposure (using multiple Cis Instruments, LD </a:t>
            </a:r>
            <a:r>
              <a:rPr lang="en-GB" b="0" i="0" u="none" strike="noStrike" dirty="0" err="1">
                <a:solidFill>
                  <a:srgbClr val="000000"/>
                </a:solidFill>
                <a:effectLst/>
                <a:latin typeface="Calibri" panose="020F0502020204030204" pitchFamily="34" charset="0"/>
              </a:rPr>
              <a:t>Rsq</a:t>
            </a:r>
            <a:r>
              <a:rPr lang="en-GB" b="0" i="0" u="none" strike="noStrike" dirty="0">
                <a:solidFill>
                  <a:srgbClr val="000000"/>
                </a:solidFill>
                <a:effectLst/>
                <a:latin typeface="Calibri" panose="020F0502020204030204" pitchFamily="34" charset="0"/>
              </a:rPr>
              <a:t>&lt;0.3) and AD is the outcome</a:t>
            </a:r>
            <a:r>
              <a:rPr lang="en-GB" b="0" i="0" u="none" strike="noStrike" dirty="0">
                <a:solidFill>
                  <a:srgbClr val="000000"/>
                </a:solidFill>
                <a:effectLst/>
                <a:latin typeface="Times New Roman" panose="02020603050405020304" pitchFamily="18" charset="0"/>
              </a:rPr>
              <a:t> in MR analyses. Each point in the scatter plot represents an instrumental SNP and different regression lines represents the different MR methods used. The package “</a:t>
            </a:r>
            <a:r>
              <a:rPr lang="en-GB" b="0" i="0" u="none" strike="noStrike" dirty="0" err="1">
                <a:solidFill>
                  <a:srgbClr val="000000"/>
                </a:solidFill>
                <a:effectLst/>
                <a:latin typeface="Times New Roman" panose="02020603050405020304" pitchFamily="18" charset="0"/>
              </a:rPr>
              <a:t>MendelianRandomization</a:t>
            </a:r>
            <a:r>
              <a:rPr lang="en-GB" b="0" i="0" u="none" strike="noStrike" dirty="0">
                <a:solidFill>
                  <a:srgbClr val="000000"/>
                </a:solidFill>
                <a:effectLst/>
                <a:latin typeface="Times New Roman" panose="02020603050405020304" pitchFamily="18" charset="0"/>
              </a:rPr>
              <a:t>” was used for these cis-MR analyses. </a:t>
            </a:r>
            <a:endParaRPr lang="en-GB" dirty="0"/>
          </a:p>
        </p:txBody>
      </p:sp>
      <p:pic>
        <p:nvPicPr>
          <p:cNvPr id="5" name="Picture 4">
            <a:extLst>
              <a:ext uri="{FF2B5EF4-FFF2-40B4-BE49-F238E27FC236}">
                <a16:creationId xmlns:a16="http://schemas.microsoft.com/office/drawing/2014/main" id="{3216D703-BAF5-1B09-02CD-4720B2894D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225149" y="513038"/>
            <a:ext cx="5741701" cy="4943486"/>
          </a:xfrm>
          <a:prstGeom prst="rect">
            <a:avLst/>
          </a:prstGeom>
        </p:spPr>
      </p:pic>
    </p:spTree>
    <p:extLst>
      <p:ext uri="{BB962C8B-B14F-4D97-AF65-F5344CB8AC3E}">
        <p14:creationId xmlns:p14="http://schemas.microsoft.com/office/powerpoint/2010/main" val="11715820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TotalTime>
  <Words>197</Words>
  <Application>Microsoft Macintosh PowerPoint</Application>
  <PresentationFormat>Widescreen</PresentationFormat>
  <Paragraphs>10</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u, Jin</dc:creator>
  <cp:lastModifiedBy>Xu, Jin</cp:lastModifiedBy>
  <cp:revision>2</cp:revision>
  <dcterms:created xsi:type="dcterms:W3CDTF">2022-08-04T15:47:41Z</dcterms:created>
  <dcterms:modified xsi:type="dcterms:W3CDTF">2022-09-02T06:58:15Z</dcterms:modified>
</cp:coreProperties>
</file>